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06A127-B705-490A-BD60-501794E4EC5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DD3965E-FDA8-4BC1-BAEB-71BA079D29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31157DB-CFE4-455A-B1F7-6233D69C9E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844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844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10D9D20-3C94-4D15-BA40-997C600A7C7F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0193264-E1A0-4368-A482-738665445F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D907681-6CBB-48E1-9ABC-9EC067ADCD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8E38DA2-5F33-4119-A669-C53614EE93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B61F285-771C-43E7-9453-C4D2A44B26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4160" cy="613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F94570-12B7-4EFA-B094-2EF149C858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29023F6-C1A3-4CCE-A31F-05779A2BE9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5E78085-7861-4E0D-BFD4-B8A1210F18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710A79-396A-4D5C-B1B4-757ABB678A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1/30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8074364C-B2F2-4957-9479-3D17763AF489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784600" y="1679400"/>
            <a:ext cx="1825560" cy="14400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522520" y="1679400"/>
            <a:ext cx="287280" cy="144000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2249640" y="1474920"/>
            <a:ext cx="3241440" cy="2041560"/>
            <a:chOff x="2249640" y="1474920"/>
            <a:chExt cx="3241440" cy="2041560"/>
          </a:xfrm>
        </p:grpSpPr>
        <p:sp>
          <p:nvSpPr>
            <p:cNvPr id="44" name=""/>
            <p:cNvSpPr/>
            <p:nvPr/>
          </p:nvSpPr>
          <p:spPr>
            <a:xfrm>
              <a:off x="2249640" y="1542960"/>
              <a:ext cx="268200" cy="19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9144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519280" y="1474920"/>
              <a:ext cx="2971800" cy="27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2171880"/>
                  <a:tab algn="l" pos="289548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M      6     13     16     17     19    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6" name=""/>
            <p:cNvCxnSpPr/>
            <p:nvPr/>
          </p:nvCxnSpPr>
          <p:spPr>
            <a:xfrm flipV="1" rot="10800000">
              <a:off x="4323600" y="2433240"/>
              <a:ext cx="288000" cy="2520"/>
            </a:xfrm>
            <a:prstGeom prst="bentConnector3">
              <a:avLst>
                <a:gd name="adj1" fmla="val 49937"/>
              </a:avLst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7" name=""/>
            <p:cNvCxnSpPr/>
            <p:nvPr/>
          </p:nvCxnSpPr>
          <p:spPr>
            <a:xfrm flipV="1" rot="10800000">
              <a:off x="4323600" y="1879200"/>
              <a:ext cx="288000" cy="2520"/>
            </a:xfrm>
            <a:prstGeom prst="bentConnector3">
              <a:avLst>
                <a:gd name="adj1" fmla="val 49937"/>
              </a:avLst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8" name=""/>
            <p:cNvSpPr/>
            <p:nvPr/>
          </p:nvSpPr>
          <p:spPr>
            <a:xfrm>
              <a:off x="4849920" y="1812960"/>
              <a:ext cx="468360" cy="28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tIns="914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V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849920" y="2359080"/>
              <a:ext cx="468360" cy="28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tIns="9144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VP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0" name="" descr=""/>
          <p:cNvPicPr/>
          <p:nvPr/>
        </p:nvPicPr>
        <p:blipFill>
          <a:blip r:embed="rId3"/>
          <a:stretch/>
        </p:blipFill>
        <p:spPr>
          <a:xfrm>
            <a:off x="5318280" y="1679400"/>
            <a:ext cx="922320" cy="14400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5318280" y="1474920"/>
            <a:ext cx="2971800" cy="27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Calibri"/>
              </a:rPr>
              <a:t>M    -ve  crude 16   17   +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4"/>
          <a:stretch/>
        </p:blipFill>
        <p:spPr>
          <a:xfrm>
            <a:off x="6199200" y="1679400"/>
            <a:ext cx="826920" cy="1440000"/>
          </a:xfrm>
          <a:prstGeom prst="rect">
            <a:avLst/>
          </a:prstGeom>
          <a:ln w="0">
            <a:noFill/>
          </a:ln>
        </p:spPr>
      </p:pic>
      <p:cxnSp>
        <p:nvCxnSpPr>
          <p:cNvPr id="53" name=""/>
          <p:cNvCxnSpPr/>
          <p:nvPr/>
        </p:nvCxnSpPr>
        <p:spPr>
          <a:xfrm flipV="1" rot="10800000">
            <a:off x="6753960" y="2507760"/>
            <a:ext cx="288360" cy="2520"/>
          </a:xfrm>
          <a:prstGeom prst="bentConnector3">
            <a:avLst>
              <a:gd name="adj1" fmla="val 50000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"/>
          <p:cNvSpPr/>
          <p:nvPr/>
        </p:nvSpPr>
        <p:spPr>
          <a:xfrm>
            <a:off x="7281720" y="2433600"/>
            <a:ext cx="4683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Calibri"/>
              </a:rPr>
              <a:t>VP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21920" y="2949480"/>
            <a:ext cx="3236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025600" y="2949480"/>
            <a:ext cx="3236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849320" y="3203640"/>
            <a:ext cx="6096240" cy="232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1: Figure S1. Analysis of sucrose density gradient purified VP2/6.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A) Western blot analysis of VP2/6 fractions using mouse anti-VP6 (1:5000) and anti-His (1:2000). B) SDS-PAGE coomassie stained gel of fractions. -ve – Fraction 16 of plants infiltrated with silencing suppressor only and sucrose gradient purified. +ve – VP6 expressed in insect cells. Arrows indicate protein band siz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